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10">
            <a:extLst>
              <a:ext uri="{FF2B5EF4-FFF2-40B4-BE49-F238E27FC236}">
                <a16:creationId xmlns:a16="http://schemas.microsoft.com/office/drawing/2014/main" id="{0D4F0C7C-7FF2-442D-A6F7-F29BC88818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959" y="786590"/>
            <a:ext cx="5533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BDC635-B22A-497A-B930-662E9FE3951C}"/>
              </a:ext>
            </a:extLst>
          </p:cNvPr>
          <p:cNvSpPr txBox="1"/>
          <p:nvPr/>
        </p:nvSpPr>
        <p:spPr>
          <a:xfrm>
            <a:off x="340343" y="2094284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ippin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6">
            <a:extLst>
              <a:ext uri="{FF2B5EF4-FFF2-40B4-BE49-F238E27FC236}">
                <a16:creationId xmlns:a16="http://schemas.microsoft.com/office/drawing/2014/main" id="{6C48B69D-35B1-40E6-9E74-ED2EF50760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7159" y="1160662"/>
            <a:ext cx="131478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) flies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3385CFF2-3D61-4EF0-94B8-93CE7BF49C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7998" y="2163739"/>
            <a:ext cx="2309213" cy="168436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6A07E631-B80C-4CED-9DAA-5761F56A19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3094" y="2148727"/>
            <a:ext cx="2285571" cy="1682434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84F998CA-2378-4CFF-BC32-D89F74BFC3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12886" y="2090505"/>
            <a:ext cx="2297278" cy="1684368"/>
          </a:xfrm>
          <a:prstGeom prst="rect">
            <a:avLst/>
          </a:prstGeom>
        </p:spPr>
      </p:pic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8184F1D9-3881-45B2-8CFE-87C95D0040CE}"/>
              </a:ext>
            </a:extLst>
          </p:cNvPr>
          <p:cNvCxnSpPr/>
          <p:nvPr/>
        </p:nvCxnSpPr>
        <p:spPr>
          <a:xfrm>
            <a:off x="1101779" y="3618754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3CD17F52-890F-4DA6-A477-C610DE32228D}"/>
              </a:ext>
            </a:extLst>
          </p:cNvPr>
          <p:cNvSpPr txBox="1"/>
          <p:nvPr/>
        </p:nvSpPr>
        <p:spPr>
          <a:xfrm>
            <a:off x="406066" y="3457097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ces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8D66C795-0588-48E2-AB0C-FFAC71F0F30C}"/>
              </a:ext>
            </a:extLst>
          </p:cNvPr>
          <p:cNvCxnSpPr/>
          <p:nvPr/>
        </p:nvCxnSpPr>
        <p:spPr>
          <a:xfrm>
            <a:off x="4616875" y="2207450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1DC7E26-96D6-4E6E-806B-67A4C0ED06DA}"/>
              </a:ext>
            </a:extLst>
          </p:cNvPr>
          <p:cNvSpPr txBox="1"/>
          <p:nvPr/>
        </p:nvSpPr>
        <p:spPr>
          <a:xfrm>
            <a:off x="3855439" y="2037639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ippin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25DF3684-B637-4166-821C-A625C937A209}"/>
              </a:ext>
            </a:extLst>
          </p:cNvPr>
          <p:cNvCxnSpPr/>
          <p:nvPr/>
        </p:nvCxnSpPr>
        <p:spPr>
          <a:xfrm>
            <a:off x="4616875" y="3601809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32493C1-30E9-4CA4-908E-1583634E6041}"/>
              </a:ext>
            </a:extLst>
          </p:cNvPr>
          <p:cNvSpPr txBox="1"/>
          <p:nvPr/>
        </p:nvSpPr>
        <p:spPr>
          <a:xfrm>
            <a:off x="3921162" y="3430873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ces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DE5B9538-A124-43EE-93B0-019009B19448}"/>
              </a:ext>
            </a:extLst>
          </p:cNvPr>
          <p:cNvCxnSpPr/>
          <p:nvPr/>
        </p:nvCxnSpPr>
        <p:spPr>
          <a:xfrm>
            <a:off x="8446667" y="2140539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0E355199-4370-4C71-90CE-5062B5D987D5}"/>
              </a:ext>
            </a:extLst>
          </p:cNvPr>
          <p:cNvSpPr txBox="1"/>
          <p:nvPr/>
        </p:nvSpPr>
        <p:spPr>
          <a:xfrm>
            <a:off x="7685231" y="2002039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ipping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B64048A5-5B22-452A-B457-AC9A6A4A804D}"/>
              </a:ext>
            </a:extLst>
          </p:cNvPr>
          <p:cNvCxnSpPr/>
          <p:nvPr/>
        </p:nvCxnSpPr>
        <p:spPr>
          <a:xfrm>
            <a:off x="8446667" y="3534898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63D48ABF-9D23-4A6A-B560-89DFE975D2D3}"/>
              </a:ext>
            </a:extLst>
          </p:cNvPr>
          <p:cNvSpPr txBox="1"/>
          <p:nvPr/>
        </p:nvSpPr>
        <p:spPr>
          <a:xfrm>
            <a:off x="7750954" y="3388034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ces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25059DF6-37D7-47EA-A998-384BE649DF27}"/>
              </a:ext>
            </a:extLst>
          </p:cNvPr>
          <p:cNvCxnSpPr/>
          <p:nvPr/>
        </p:nvCxnSpPr>
        <p:spPr>
          <a:xfrm>
            <a:off x="1101779" y="2232784"/>
            <a:ext cx="21375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A9DD90C-A1BF-469D-A7A7-8911C214A311}"/>
              </a:ext>
            </a:extLst>
          </p:cNvPr>
          <p:cNvSpPr txBox="1"/>
          <p:nvPr/>
        </p:nvSpPr>
        <p:spPr>
          <a:xfrm>
            <a:off x="4126001" y="878106"/>
            <a:ext cx="2334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ipping behavior over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93791AEC-FC3E-4FF6-93D7-1F2E93553E0B}"/>
              </a:ext>
            </a:extLst>
          </p:cNvPr>
          <p:cNvCxnSpPr/>
          <p:nvPr/>
        </p:nvCxnSpPr>
        <p:spPr>
          <a:xfrm>
            <a:off x="1074717" y="1810986"/>
            <a:ext cx="937556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 Box 17">
            <a:extLst>
              <a:ext uri="{FF2B5EF4-FFF2-40B4-BE49-F238E27FC236}">
                <a16:creationId xmlns:a16="http://schemas.microsoft.com/office/drawing/2014/main" id="{47EBB826-4A7C-4A9B-9F83-412F62FB17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8073" y="1418367"/>
            <a:ext cx="169950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 in food (5 mM)</a:t>
            </a:r>
          </a:p>
        </p:txBody>
      </p:sp>
    </p:spTree>
    <p:extLst>
      <p:ext uri="{BB962C8B-B14F-4D97-AF65-F5344CB8AC3E}">
        <p14:creationId xmlns:p14="http://schemas.microsoft.com/office/powerpoint/2010/main" val="2062406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24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4:58Z</dcterms:modified>
</cp:coreProperties>
</file>